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576" y="-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623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873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45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551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102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191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877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0631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9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71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576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81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8DE1177-A61A-7AD0-39DC-A974AD2592FC}"/>
              </a:ext>
            </a:extLst>
          </p:cNvPr>
          <p:cNvSpPr txBox="1"/>
          <p:nvPr/>
        </p:nvSpPr>
        <p:spPr>
          <a:xfrm>
            <a:off x="234214" y="5817311"/>
            <a:ext cx="8640279" cy="13235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2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orest plot of the prognostic effect of relevant variables on PFS</a:t>
            </a:r>
            <a:r>
              <a:rPr lang="en-US" altLang="zh-CN" sz="1400" kern="1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R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re derived using Cox proportional hazards regression models and presented with 95% CIs. </a:t>
            </a:r>
            <a:endParaRPr lang="zh-CN" altLang="zh-CN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 descr="图表, 箱线图&#10;&#10;描述已自动生成">
            <a:extLst>
              <a:ext uri="{FF2B5EF4-FFF2-40B4-BE49-F238E27FC236}">
                <a16:creationId xmlns:a16="http://schemas.microsoft.com/office/drawing/2014/main" id="{8ADDC973-922A-BCA5-BB88-A09189FD8B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382" y="148072"/>
            <a:ext cx="7709823" cy="57051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037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</TotalTime>
  <Words>33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g Dai</dc:creator>
  <cp:lastModifiedBy>Ying Dai</cp:lastModifiedBy>
  <cp:revision>2</cp:revision>
  <dcterms:created xsi:type="dcterms:W3CDTF">2023-12-11T13:09:18Z</dcterms:created>
  <dcterms:modified xsi:type="dcterms:W3CDTF">2023-12-11T13:18:41Z</dcterms:modified>
</cp:coreProperties>
</file>